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8" r:id="rId2"/>
    <p:sldId id="269" r:id="rId3"/>
  </p:sldIdLst>
  <p:sldSz cx="6858000" cy="9144000" type="screen4x3"/>
  <p:notesSz cx="6811963" cy="99425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>
        <p:scale>
          <a:sx n="72" d="100"/>
          <a:sy n="72" d="100"/>
        </p:scale>
        <p:origin x="2048" y="-7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851" cy="497126"/>
          </a:xfrm>
          <a:prstGeom prst="rect">
            <a:avLst/>
          </a:prstGeom>
        </p:spPr>
        <p:txBody>
          <a:bodyPr vert="horz" lIns="95727" tIns="47864" rIns="95727" bIns="47864" rtlCol="0"/>
          <a:lstStyle>
            <a:lvl1pPr algn="l">
              <a:defRPr sz="13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8536" y="0"/>
            <a:ext cx="2951851" cy="497126"/>
          </a:xfrm>
          <a:prstGeom prst="rect">
            <a:avLst/>
          </a:prstGeom>
        </p:spPr>
        <p:txBody>
          <a:bodyPr vert="horz" lIns="95727" tIns="47864" rIns="95727" bIns="47864" rtlCol="0"/>
          <a:lstStyle>
            <a:lvl1pPr algn="r">
              <a:defRPr sz="1300"/>
            </a:lvl1pPr>
          </a:lstStyle>
          <a:p>
            <a:fld id="{B684076D-E630-431C-892B-DFB82B097D5E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8188" y="744538"/>
            <a:ext cx="2795587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727" tIns="47864" rIns="95727" bIns="47864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1197" y="4722695"/>
            <a:ext cx="5449570" cy="4474131"/>
          </a:xfrm>
          <a:prstGeom prst="rect">
            <a:avLst/>
          </a:prstGeom>
        </p:spPr>
        <p:txBody>
          <a:bodyPr vert="horz" lIns="95727" tIns="47864" rIns="95727" bIns="47864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43662"/>
            <a:ext cx="2951851" cy="497126"/>
          </a:xfrm>
          <a:prstGeom prst="rect">
            <a:avLst/>
          </a:prstGeom>
        </p:spPr>
        <p:txBody>
          <a:bodyPr vert="horz" lIns="95727" tIns="47864" rIns="95727" bIns="47864" rtlCol="0" anchor="b"/>
          <a:lstStyle>
            <a:lvl1pPr algn="l">
              <a:defRPr sz="13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8536" y="9443662"/>
            <a:ext cx="2951851" cy="497126"/>
          </a:xfrm>
          <a:prstGeom prst="rect">
            <a:avLst/>
          </a:prstGeom>
        </p:spPr>
        <p:txBody>
          <a:bodyPr vert="horz" lIns="95727" tIns="47864" rIns="95727" bIns="47864" rtlCol="0" anchor="b"/>
          <a:lstStyle>
            <a:lvl1pPr algn="r">
              <a:defRPr sz="1300"/>
            </a:lvl1pPr>
          </a:lstStyle>
          <a:p>
            <a:fld id="{DE8A474D-2E2F-451B-A9AA-D303ABD4240D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06413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6BC11-82FA-44D1-BE5F-DA451295A61B}" type="datetimeFigureOut">
              <a:rPr lang="fr-FR" smtClean="0"/>
              <a:pPr/>
              <a:t>11/0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EA24D-6A26-4C08-9641-107CD13E3130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2643182" y="5025622"/>
            <a:ext cx="1847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fr-FR" dirty="0"/>
          </a:p>
        </p:txBody>
      </p:sp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38894251"/>
              </p:ext>
            </p:extLst>
          </p:nvPr>
        </p:nvGraphicFramePr>
        <p:xfrm>
          <a:off x="1250132" y="1042988"/>
          <a:ext cx="4123084" cy="30230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410" name="Prism 5" r:id="rId3" imgW="3038760" imgH="2225160" progId="Prism5.Document">
                  <p:embed/>
                </p:oleObj>
              </mc:Choice>
              <mc:Fallback>
                <p:oleObj name="Prism 5" r:id="rId3" imgW="3038760" imgH="22251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50132" y="1042988"/>
                        <a:ext cx="4123084" cy="30230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ZoneTexte 2"/>
          <p:cNvSpPr txBox="1"/>
          <p:nvPr/>
        </p:nvSpPr>
        <p:spPr>
          <a:xfrm>
            <a:off x="188640" y="539552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228098" y="3851920"/>
            <a:ext cx="4830168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bacho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C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induced relaxation in aortas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oung rats (YWR: 16 weeks old) in the absence and in the presence </a:t>
            </a:r>
            <a:endParaRPr 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NAME (100 µM). (***p&lt;0.001, +L-NAME versus without L-NAM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expressed in mean ± SD with n=5 per group)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29895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2643182" y="5025622"/>
            <a:ext cx="1847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188640" y="539552"/>
            <a:ext cx="2578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2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1650032" y="1188110"/>
            <a:ext cx="2551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fr-F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Obje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7202844"/>
              </p:ext>
            </p:extLst>
          </p:nvPr>
        </p:nvGraphicFramePr>
        <p:xfrm>
          <a:off x="1709738" y="1120775"/>
          <a:ext cx="4167534" cy="3071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433" name="Prism 5" r:id="rId3" imgW="3029760" imgH="2232720" progId="Prism5.Document">
                  <p:embed/>
                </p:oleObj>
              </mc:Choice>
              <mc:Fallback>
                <p:oleObj name="Prism 5" r:id="rId3" imgW="3029760" imgH="2232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09738" y="1120775"/>
                        <a:ext cx="4167534" cy="3071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260648" y="4427984"/>
            <a:ext cx="547260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rbacho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Ch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induc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xation 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senteric arteries from young rats (YWR: 16 weeks old) 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enc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n presence of L-NAME (100 µM). (**p&lt;0.01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-NAME versus without L-NAME;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ult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express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± SD with n=5 per group)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69842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81</TotalTime>
  <Words>118</Words>
  <Application>Microsoft Office PowerPoint</Application>
  <PresentationFormat>Affichage à l'écran (4:3)</PresentationFormat>
  <Paragraphs>9</Paragraphs>
  <Slides>2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Times New Roman</vt:lpstr>
      <vt:lpstr>Thème Office</vt:lpstr>
      <vt:lpstr>Prism 5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ngela</dc:creator>
  <cp:lastModifiedBy>tesse-a</cp:lastModifiedBy>
  <cp:revision>229</cp:revision>
  <cp:lastPrinted>2018-05-24T14:57:42Z</cp:lastPrinted>
  <dcterms:created xsi:type="dcterms:W3CDTF">2013-07-08T09:44:06Z</dcterms:created>
  <dcterms:modified xsi:type="dcterms:W3CDTF">2019-02-11T05:07:58Z</dcterms:modified>
</cp:coreProperties>
</file>